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14466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5500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5486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67186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84912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71304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18794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15377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96502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15822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49606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FC897-D2BD-4F37-B349-BBE17A210B8A}" type="datetimeFigureOut">
              <a:rPr lang="hu-HU" smtClean="0"/>
              <a:t>2022. 10. 1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F330F-8F36-432A-AFA3-53B97AF6E46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97959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2318908" y="115976"/>
            <a:ext cx="17988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fumigatu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Egyenes összekötő 5"/>
          <p:cNvCxnSpPr/>
          <p:nvPr/>
        </p:nvCxnSpPr>
        <p:spPr>
          <a:xfrm>
            <a:off x="312008" y="1088423"/>
            <a:ext cx="16476" cy="37800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zövegdoboz 6"/>
          <p:cNvSpPr txBox="1"/>
          <p:nvPr/>
        </p:nvSpPr>
        <p:spPr>
          <a:xfrm>
            <a:off x="11284" y="490418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1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Egyenes összekötő 8"/>
          <p:cNvCxnSpPr/>
          <p:nvPr/>
        </p:nvCxnSpPr>
        <p:spPr>
          <a:xfrm>
            <a:off x="314325" y="1245586"/>
            <a:ext cx="0" cy="108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Szövegdoboz 11"/>
          <p:cNvSpPr txBox="1"/>
          <p:nvPr/>
        </p:nvSpPr>
        <p:spPr>
          <a:xfrm>
            <a:off x="320246" y="1114920"/>
            <a:ext cx="1707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1:131310-151994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églalap 14"/>
          <p:cNvSpPr/>
          <p:nvPr/>
        </p:nvSpPr>
        <p:spPr>
          <a:xfrm>
            <a:off x="2027765" y="549960"/>
            <a:ext cx="640649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90      biotin-dependent 2-oxo acid dehydrogenases acyltransferase, putative 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8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amine-6-phosphate deamin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7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ine aldehyde dehydrogen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6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oline oxid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5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-acetylglucosamine-6-phosphate deacetyl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4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F895 domain membrane protein (N-acety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</a:t>
            </a:r>
            <a:r>
              <a:rPr lang="hu-H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ine transporter)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2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boxypeptidase S1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1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6 transcription factor, putative</a:t>
            </a:r>
          </a:p>
          <a:p>
            <a:r>
              <a:rPr lang="en-US" sz="1200" dirty="0" smtClean="0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1g00400</a:t>
            </a:r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hypothetical protein </a:t>
            </a:r>
            <a:endParaRPr lang="en-US" sz="1200" dirty="0" smtClean="0">
              <a:solidFill>
                <a:srgbClr val="00B05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6" name="Egyenes összekötő 15"/>
          <p:cNvCxnSpPr/>
          <p:nvPr/>
        </p:nvCxnSpPr>
        <p:spPr>
          <a:xfrm>
            <a:off x="1252164" y="3068423"/>
            <a:ext cx="16476" cy="18000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Szövegdoboz 16"/>
          <p:cNvSpPr txBox="1"/>
          <p:nvPr/>
        </p:nvSpPr>
        <p:spPr>
          <a:xfrm>
            <a:off x="1037165" y="4904181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8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Egyenes összekötő 17"/>
          <p:cNvCxnSpPr/>
          <p:nvPr/>
        </p:nvCxnSpPr>
        <p:spPr>
          <a:xfrm>
            <a:off x="1254481" y="3749460"/>
            <a:ext cx="0" cy="108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Szövegdoboz 18"/>
          <p:cNvSpPr txBox="1"/>
          <p:nvPr/>
        </p:nvSpPr>
        <p:spPr>
          <a:xfrm>
            <a:off x="1260402" y="3642235"/>
            <a:ext cx="1689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8:882503-904290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églalap 19"/>
          <p:cNvSpPr/>
          <p:nvPr/>
        </p:nvSpPr>
        <p:spPr>
          <a:xfrm>
            <a:off x="2846915" y="2978423"/>
            <a:ext cx="640649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060      beta-N-</a:t>
            </a:r>
            <a:r>
              <a:rPr lang="en-US" sz="1200" dirty="0" err="1" smtClean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etylglucosaminidase</a:t>
            </a:r>
            <a:r>
              <a:rPr lang="en-US" sz="1200" dirty="0" smtClean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utative 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07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amine-6-phosphate deamin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08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ine aldehyde dehydrogen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09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oline oxid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10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-acetylglucosamine-6-phosphate deacetylase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11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F895 domain membrane protein (N-acety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</a:t>
            </a:r>
            <a:r>
              <a:rPr lang="hu-H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ine transporter)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12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boxypeptidase S1, putative</a:t>
            </a:r>
          </a:p>
          <a:p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130    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6 transcription factor, putative</a:t>
            </a:r>
          </a:p>
          <a:p>
            <a:r>
              <a:rPr lang="en-US" sz="1200" dirty="0" smtClean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u8g04140</a:t>
            </a:r>
            <a:r>
              <a:rPr lang="en-US" sz="12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conserved hypothetical protein</a:t>
            </a:r>
            <a:endParaRPr lang="en-US" sz="1200" dirty="0" smtClean="0">
              <a:solidFill>
                <a:srgbClr val="0070C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1" name="Egyenes összekötő 20"/>
          <p:cNvCxnSpPr/>
          <p:nvPr/>
        </p:nvCxnSpPr>
        <p:spPr>
          <a:xfrm>
            <a:off x="11405814" y="3068423"/>
            <a:ext cx="16476" cy="18000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Szövegdoboz 21"/>
          <p:cNvSpPr txBox="1"/>
          <p:nvPr/>
        </p:nvSpPr>
        <p:spPr>
          <a:xfrm>
            <a:off x="10962215" y="4904181"/>
            <a:ext cx="938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f00007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Egyenes összekötő 22"/>
          <p:cNvCxnSpPr/>
          <p:nvPr/>
        </p:nvCxnSpPr>
        <p:spPr>
          <a:xfrm>
            <a:off x="11408131" y="3749460"/>
            <a:ext cx="0" cy="1080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Szövegdoboz 23"/>
          <p:cNvSpPr txBox="1"/>
          <p:nvPr/>
        </p:nvSpPr>
        <p:spPr>
          <a:xfrm>
            <a:off x="9256194" y="3642235"/>
            <a:ext cx="22092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f00007:1029461-1050960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églalap 24"/>
          <p:cNvSpPr/>
          <p:nvPr/>
        </p:nvSpPr>
        <p:spPr>
          <a:xfrm>
            <a:off x="8279006" y="2978423"/>
            <a:ext cx="1132041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UB_08350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9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8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7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6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5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40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UB_083430</a:t>
            </a:r>
          </a:p>
          <a:p>
            <a:r>
              <a:rPr lang="en-US" sz="12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UB_083420</a:t>
            </a:r>
          </a:p>
        </p:txBody>
      </p:sp>
      <p:sp>
        <p:nvSpPr>
          <p:cNvPr id="26" name="Szövegdoboz 25"/>
          <p:cNvSpPr txBox="1"/>
          <p:nvPr/>
        </p:nvSpPr>
        <p:spPr>
          <a:xfrm>
            <a:off x="9151338" y="2312285"/>
            <a:ext cx="1824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fumigatu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1163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Szövegdoboz 26"/>
          <p:cNvSpPr txBox="1"/>
          <p:nvPr/>
        </p:nvSpPr>
        <p:spPr>
          <a:xfrm>
            <a:off x="120850" y="5800218"/>
            <a:ext cx="1185862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sition of N-acetyl glucosamine transporter, glucosamine-6-phosphate deaminase, and N-acetylglucosamine-6-phosphate deacetylase genes in the genome of 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fumigatus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293 and A1163.</a:t>
            </a:r>
            <a:endParaRPr lang="hu-HU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was created with the data of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giDB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https://fungidb.org/fungidb/app) and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iniG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http://bioinformatics.sdstate.edu/go/).</a:t>
            </a:r>
            <a:endParaRPr lang="hu-H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8250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76</Words>
  <Application>Microsoft Office PowerPoint</Application>
  <PresentationFormat>Szélesvásznú</PresentationFormat>
  <Paragraphs>37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9</cp:revision>
  <dcterms:created xsi:type="dcterms:W3CDTF">2022-07-21T10:59:37Z</dcterms:created>
  <dcterms:modified xsi:type="dcterms:W3CDTF">2022-10-12T05:59:55Z</dcterms:modified>
</cp:coreProperties>
</file>